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5" r:id="rId3"/>
    <p:sldId id="260" r:id="rId4"/>
    <p:sldId id="261" r:id="rId5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35"/>
  </p:normalViewPr>
  <p:slideViewPr>
    <p:cSldViewPr snapToGrid="0">
      <p:cViewPr varScale="1">
        <p:scale>
          <a:sx n="118" d="100"/>
          <a:sy n="118" d="100"/>
        </p:scale>
        <p:origin x="3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8E3E0-CF2C-AC05-3D02-20040C66DF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B5FB67-31E1-E7C7-3A37-B1630F4B1F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FDBBF8-1E74-D8E9-2304-82839777D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A2409C-0028-B6D7-5115-48CA13293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085B2-92E1-F8EA-7628-273705822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768968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BF7D16-8D93-7406-E8A4-14F1076A2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832307-B67E-AB7C-C4C8-2E6886F9E8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E6B8C2-3670-F282-660E-447B84582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465989-EDEB-3C8E-2E61-6AE6FD721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DA7F10-6CAC-7820-76D2-39CAEC1FC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051126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616E86-309B-B0E9-7639-4B3CEEF1AA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4499B7-4119-F099-6A62-9BE6A6984E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22C273-B775-5CB0-3A2C-EB528A5AF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863B2-0F96-3929-22EF-C61C6DAD6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5F407-24B2-31EE-A002-15CAD30A3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665942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1693C0-9C52-69A6-0C5D-57D1E48FB4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FDF46-1BEB-12A8-A8A5-9DEBDF6D64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755F60-0EB6-FCC6-769C-CBF1292CB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0CF0AB-6460-D0BB-74BD-CBFC37177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8A152-621A-8429-5574-E5A6E9A5C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2556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E9183-8787-F746-F4F3-6A5594C05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DC0679-5016-5781-63DB-88F8C77FC8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3EDA8E-1704-845C-7489-B307B1474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CF30F6-C8F3-D29B-E65F-BFD693D83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6A6505-7D2C-D7BC-2030-23E957424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533099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7D60DA-F891-9C18-5BE7-9E6FBBCC60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AD159E-7950-1D0B-F0DE-25AE9E3CBC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AA417E-A910-CEFC-2B96-62992A1681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FCC2D4-7400-D2C1-E97C-2B8070035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C4DCE1-CBBE-1DD8-73E0-6C0D37A6C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E1F543-E1AC-CB9D-7BB5-7334EFF99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632479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D4C12D-FF4E-8751-8D61-CCD2A5AF2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AF0BCA-2992-9AEB-5DB3-FB5B25AB65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6880A8-C6AC-F80F-885B-F80053E688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BA476B-5238-640E-002E-A1C95295DC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5BA1A6-11AF-1B84-7548-3D800803F5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DC5337-8C52-D82B-141B-79DE3D337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612807-8A4B-CF54-A7FA-520689B93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2849408-B18F-23A8-C337-187D2EB2F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12608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B9122-5F8D-F69D-75E0-4BF4D8B070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BE5D43-D1F4-5125-A138-C9B3D5F89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6C288C-4213-D862-8A18-D616DE885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74EEF6-AD7B-B655-B543-736474469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442098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0B61F8-9341-034C-58BD-5B272BDA2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F42164-408B-ED29-4E89-2E1BA445D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307AA5-64BE-CA52-8C46-0482A6A0E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849545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202524-5F5C-77ED-7E30-28DE2BFC3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36D6FA-97A6-151E-25C1-842B8D6CF8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9EED6F-A6CF-4BE2-E478-EC4459F43A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5CB432-3334-1442-3BF8-FDE664A00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1639AF-6D42-AB7B-995D-CED616AE2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CAB66E-93C2-B121-ED5F-1E422BA82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2973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5915B-9093-DB9F-AB9A-ECE62BE08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463168-90A2-FDE4-1B2E-1B7D164D23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59734B-6434-0FA5-07CD-1667EA0294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6DB46C-E1FB-F0CE-4AB1-67A16F042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A7B579-61BA-858F-795B-D0502D65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AE1EF9-426E-FC10-F4A6-248FF565D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02387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9FC66D3-1B46-87C9-68C6-73627A93EB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F8E60E-DD0B-0502-7F00-89262A3AE6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DF0A17-2D84-464F-340F-CE9B404AFD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A0F33-BB58-AE43-B83D-4CE7A8C11B39}" type="datetimeFigureOut">
              <a:rPr lang="en-BE" smtClean="0"/>
              <a:t>01/10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76CA80-333E-FBD7-39DB-A061014106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6CAA5A-676F-CC76-9D1B-5ADDF05844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75879-7AD2-D245-B2FC-CB741D29BE2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834541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urry image of a white background&#10;&#10;Description automatically generated">
            <a:extLst>
              <a:ext uri="{FF2B5EF4-FFF2-40B4-BE49-F238E27FC236}">
                <a16:creationId xmlns:a16="http://schemas.microsoft.com/office/drawing/2014/main" id="{15686BA4-02CB-1EC4-D508-342A80B101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9048" y="885119"/>
            <a:ext cx="7551697" cy="5487879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4B6DAE1-3106-B002-16F7-A994ADCBDF38}"/>
              </a:ext>
            </a:extLst>
          </p:cNvPr>
          <p:cNvSpPr txBox="1"/>
          <p:nvPr/>
        </p:nvSpPr>
        <p:spPr>
          <a:xfrm>
            <a:off x="361194" y="178064"/>
            <a:ext cx="1579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/>
              <a:t>STING – Native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A510D66-6036-CDAE-F9E8-C46151B16A1B}"/>
              </a:ext>
            </a:extLst>
          </p:cNvPr>
          <p:cNvGraphicFramePr>
            <a:graphicFrameLocks noGrp="1"/>
          </p:cNvGraphicFramePr>
          <p:nvPr/>
        </p:nvGraphicFramePr>
        <p:xfrm>
          <a:off x="8466851" y="1253326"/>
          <a:ext cx="3266551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3827">
                  <a:extLst>
                    <a:ext uri="{9D8B030D-6E8A-4147-A177-3AD203B41FA5}">
                      <a16:colId xmlns:a16="http://schemas.microsoft.com/office/drawing/2014/main" val="2728394959"/>
                    </a:ext>
                  </a:extLst>
                </a:gridCol>
                <a:gridCol w="793827">
                  <a:extLst>
                    <a:ext uri="{9D8B030D-6E8A-4147-A177-3AD203B41FA5}">
                      <a16:colId xmlns:a16="http://schemas.microsoft.com/office/drawing/2014/main" val="506437121"/>
                    </a:ext>
                  </a:extLst>
                </a:gridCol>
                <a:gridCol w="1678897">
                  <a:extLst>
                    <a:ext uri="{9D8B030D-6E8A-4147-A177-3AD203B41FA5}">
                      <a16:colId xmlns:a16="http://schemas.microsoft.com/office/drawing/2014/main" val="2614449367"/>
                    </a:ext>
                  </a:extLst>
                </a:gridCol>
              </a:tblGrid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99687797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070650646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325519570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625819535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307056414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414630578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603012430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688430799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99141351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427938427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717679805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897882396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731672445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360237081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56356741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KO+ 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579072504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KO+ 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05812377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KO+ 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067678810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+H-15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767705266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2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+H-15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188552537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2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TG5 KO+H-15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458977477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DA7D36E8-81A7-03A4-F471-90C0ECCA8E35}"/>
              </a:ext>
            </a:extLst>
          </p:cNvPr>
          <p:cNvSpPr/>
          <p:nvPr/>
        </p:nvSpPr>
        <p:spPr>
          <a:xfrm>
            <a:off x="1423686" y="1967696"/>
            <a:ext cx="671332" cy="269690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48AE433-DDAF-8C6B-1B9B-9CB09924004E}"/>
              </a:ext>
            </a:extLst>
          </p:cNvPr>
          <p:cNvSpPr/>
          <p:nvPr/>
        </p:nvSpPr>
        <p:spPr>
          <a:xfrm>
            <a:off x="5060066" y="2280607"/>
            <a:ext cx="671332" cy="269690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686633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white and black object&#10;&#10;Description automatically generated">
            <a:extLst>
              <a:ext uri="{FF2B5EF4-FFF2-40B4-BE49-F238E27FC236}">
                <a16:creationId xmlns:a16="http://schemas.microsoft.com/office/drawing/2014/main" id="{199C604D-EF38-7646-EAFF-5417728DB1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7331" y="935545"/>
            <a:ext cx="7329273" cy="532624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1D8B61-5ABB-5BBC-2AAB-6B6A2BD398CE}"/>
              </a:ext>
            </a:extLst>
          </p:cNvPr>
          <p:cNvSpPr txBox="1"/>
          <p:nvPr/>
        </p:nvSpPr>
        <p:spPr>
          <a:xfrm>
            <a:off x="361194" y="178064"/>
            <a:ext cx="1579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/>
              <a:t>STING – Native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ADD7940F-D762-6CE4-9C1D-23BF4DC0E082}"/>
              </a:ext>
            </a:extLst>
          </p:cNvPr>
          <p:cNvGraphicFramePr>
            <a:graphicFrameLocks noGrp="1"/>
          </p:cNvGraphicFramePr>
          <p:nvPr/>
        </p:nvGraphicFramePr>
        <p:xfrm>
          <a:off x="8466851" y="1253326"/>
          <a:ext cx="3266551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3827">
                  <a:extLst>
                    <a:ext uri="{9D8B030D-6E8A-4147-A177-3AD203B41FA5}">
                      <a16:colId xmlns:a16="http://schemas.microsoft.com/office/drawing/2014/main" val="2728394959"/>
                    </a:ext>
                  </a:extLst>
                </a:gridCol>
                <a:gridCol w="793827">
                  <a:extLst>
                    <a:ext uri="{9D8B030D-6E8A-4147-A177-3AD203B41FA5}">
                      <a16:colId xmlns:a16="http://schemas.microsoft.com/office/drawing/2014/main" val="506437121"/>
                    </a:ext>
                  </a:extLst>
                </a:gridCol>
                <a:gridCol w="1678897">
                  <a:extLst>
                    <a:ext uri="{9D8B030D-6E8A-4147-A177-3AD203B41FA5}">
                      <a16:colId xmlns:a16="http://schemas.microsoft.com/office/drawing/2014/main" val="2614449367"/>
                    </a:ext>
                  </a:extLst>
                </a:gridCol>
              </a:tblGrid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99687797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070650646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325519570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625819535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307056414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414630578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603012430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688430799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99141351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427938427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717679805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cr+ULK1 inhibition+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897882396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731672445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360237081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356356741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KO+ 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579072504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KO+ 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058123773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KO+ cGAM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067678810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0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+H-15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767705266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2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TG5 KO+H-15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2188552537"/>
                  </a:ext>
                </a:extLst>
              </a:tr>
              <a:tr h="20720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Lane 2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Z0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TG5 KO+H-15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1" marR="9141" marT="9141" marB="0" anchor="b"/>
                </a:tc>
                <a:extLst>
                  <a:ext uri="{0D108BD9-81ED-4DB2-BD59-A6C34878D82A}">
                    <a16:rowId xmlns:a16="http://schemas.microsoft.com/office/drawing/2014/main" val="1458977477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30F21297-A379-630B-33CB-3647260CE2F9}"/>
              </a:ext>
            </a:extLst>
          </p:cNvPr>
          <p:cNvSpPr/>
          <p:nvPr/>
        </p:nvSpPr>
        <p:spPr>
          <a:xfrm>
            <a:off x="5060066" y="2280607"/>
            <a:ext cx="671332" cy="269690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94C62AE-3E96-91CF-6924-900729BF4150}"/>
              </a:ext>
            </a:extLst>
          </p:cNvPr>
          <p:cNvSpPr/>
          <p:nvPr/>
        </p:nvSpPr>
        <p:spPr>
          <a:xfrm>
            <a:off x="1522209" y="2250215"/>
            <a:ext cx="671332" cy="269690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8983747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A926B50A-D7EE-C0DF-C4EB-0D23FD7BBC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8877" y="773155"/>
            <a:ext cx="7772400" cy="5649326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DB8C414-DF92-AFD5-3B53-D8530D49BD22}"/>
              </a:ext>
            </a:extLst>
          </p:cNvPr>
          <p:cNvSpPr txBox="1"/>
          <p:nvPr/>
        </p:nvSpPr>
        <p:spPr>
          <a:xfrm>
            <a:off x="4846695" y="250853"/>
            <a:ext cx="3028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/>
              <a:t>GAPDH – reducing condition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7D8B17B8-7BD5-8752-0EF5-B18D04FAFDA3}"/>
              </a:ext>
            </a:extLst>
          </p:cNvPr>
          <p:cNvGraphicFramePr>
            <a:graphicFrameLocks noGrp="1"/>
          </p:cNvGraphicFramePr>
          <p:nvPr/>
        </p:nvGraphicFramePr>
        <p:xfrm>
          <a:off x="8840966" y="1253325"/>
          <a:ext cx="2743902" cy="4351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6814">
                  <a:extLst>
                    <a:ext uri="{9D8B030D-6E8A-4147-A177-3AD203B41FA5}">
                      <a16:colId xmlns:a16="http://schemas.microsoft.com/office/drawing/2014/main" val="1870129918"/>
                    </a:ext>
                  </a:extLst>
                </a:gridCol>
                <a:gridCol w="666814">
                  <a:extLst>
                    <a:ext uri="{9D8B030D-6E8A-4147-A177-3AD203B41FA5}">
                      <a16:colId xmlns:a16="http://schemas.microsoft.com/office/drawing/2014/main" val="3579146362"/>
                    </a:ext>
                  </a:extLst>
                </a:gridCol>
                <a:gridCol w="1410274">
                  <a:extLst>
                    <a:ext uri="{9D8B030D-6E8A-4147-A177-3AD203B41FA5}">
                      <a16:colId xmlns:a16="http://schemas.microsoft.com/office/drawing/2014/main" val="72609872"/>
                    </a:ext>
                  </a:extLst>
                </a:gridCol>
              </a:tblGrid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885959163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83471874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83490994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ULK1 inhibitio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40593833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ULK1 inhibitio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26742512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ULK1 inhibitio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24444355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49710742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311022902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58154371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ULK1 inhibition+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92961898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ULK1 inhibition+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133885003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+ULK1 inhibition+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07842948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11754137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7010778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04283059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KO+ 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18136014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KO+ 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115811143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KO+ 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36385039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+H-1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76369629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+H-1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09238052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+H-1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85130536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92680308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97308008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149680906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1721454741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CDE9C730-D11B-604E-B276-A70371E832CC}"/>
              </a:ext>
            </a:extLst>
          </p:cNvPr>
          <p:cNvSpPr/>
          <p:nvPr/>
        </p:nvSpPr>
        <p:spPr>
          <a:xfrm>
            <a:off x="2893671" y="3854370"/>
            <a:ext cx="300942" cy="25464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3563BE1-2514-E87C-C9EB-0B63242643DD}"/>
              </a:ext>
            </a:extLst>
          </p:cNvPr>
          <p:cNvSpPr/>
          <p:nvPr/>
        </p:nvSpPr>
        <p:spPr>
          <a:xfrm>
            <a:off x="4824394" y="3811506"/>
            <a:ext cx="300942" cy="25464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B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3C3445-B336-0956-089A-1FF74F8E55FD}"/>
              </a:ext>
            </a:extLst>
          </p:cNvPr>
          <p:cNvSpPr txBox="1"/>
          <p:nvPr/>
        </p:nvSpPr>
        <p:spPr>
          <a:xfrm>
            <a:off x="2053920" y="3719994"/>
            <a:ext cx="50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E" dirty="0"/>
              <a:t>37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54EA7F-7404-EF5A-AB98-DDF18BBD6BC9}"/>
              </a:ext>
            </a:extLst>
          </p:cNvPr>
          <p:cNvSpPr txBox="1"/>
          <p:nvPr/>
        </p:nvSpPr>
        <p:spPr>
          <a:xfrm>
            <a:off x="6719004" y="3696817"/>
            <a:ext cx="22783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E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4183232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6E81C8A-4C90-7EDE-00AE-84311BB3CDEF}"/>
              </a:ext>
            </a:extLst>
          </p:cNvPr>
          <p:cNvSpPr txBox="1"/>
          <p:nvPr/>
        </p:nvSpPr>
        <p:spPr>
          <a:xfrm>
            <a:off x="4451277" y="341744"/>
            <a:ext cx="28230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/>
              <a:t>STING – reducing conditions</a:t>
            </a:r>
          </a:p>
        </p:txBody>
      </p:sp>
      <p:pic>
        <p:nvPicPr>
          <p:cNvPr id="12" name="Picture 11" descr="A black lines on a white surface&#10;&#10;Description automatically generated">
            <a:extLst>
              <a:ext uri="{FF2B5EF4-FFF2-40B4-BE49-F238E27FC236}">
                <a16:creationId xmlns:a16="http://schemas.microsoft.com/office/drawing/2014/main" id="{4C76B7AE-D9A3-7DF8-5149-03FF3FC210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-7458"/>
          <a:stretch/>
        </p:blipFill>
        <p:spPr>
          <a:xfrm>
            <a:off x="391874" y="711076"/>
            <a:ext cx="8352075" cy="5652654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45485B5-7E6A-6547-A00A-9D398C1BBDBB}"/>
              </a:ext>
            </a:extLst>
          </p:cNvPr>
          <p:cNvSpPr txBox="1"/>
          <p:nvPr/>
        </p:nvSpPr>
        <p:spPr>
          <a:xfrm>
            <a:off x="8164275" y="3623131"/>
            <a:ext cx="8186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BE" dirty="0"/>
              <a:t>STING</a:t>
            </a:r>
          </a:p>
        </p:txBody>
      </p:sp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68BBCEA0-D007-C911-E5AC-19BEEAFFAA4B}"/>
              </a:ext>
            </a:extLst>
          </p:cNvPr>
          <p:cNvGraphicFramePr>
            <a:graphicFrameLocks noGrp="1"/>
          </p:cNvGraphicFramePr>
          <p:nvPr/>
        </p:nvGraphicFramePr>
        <p:xfrm>
          <a:off x="9199311" y="1329588"/>
          <a:ext cx="2743902" cy="4351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6814">
                  <a:extLst>
                    <a:ext uri="{9D8B030D-6E8A-4147-A177-3AD203B41FA5}">
                      <a16:colId xmlns:a16="http://schemas.microsoft.com/office/drawing/2014/main" val="1870129918"/>
                    </a:ext>
                  </a:extLst>
                </a:gridCol>
                <a:gridCol w="666814">
                  <a:extLst>
                    <a:ext uri="{9D8B030D-6E8A-4147-A177-3AD203B41FA5}">
                      <a16:colId xmlns:a16="http://schemas.microsoft.com/office/drawing/2014/main" val="3579146362"/>
                    </a:ext>
                  </a:extLst>
                </a:gridCol>
                <a:gridCol w="1410274">
                  <a:extLst>
                    <a:ext uri="{9D8B030D-6E8A-4147-A177-3AD203B41FA5}">
                      <a16:colId xmlns:a16="http://schemas.microsoft.com/office/drawing/2014/main" val="72609872"/>
                    </a:ext>
                  </a:extLst>
                </a:gridCol>
              </a:tblGrid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885959163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83471874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83490994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Scr+ULK1 inhibit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40593833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Scr+ULK1 inhibit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26742512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Scr+ULK1 inhibit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24444355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+cGAMP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49710742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+cGAMP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2311022902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+cGAMP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58154371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Scr+ULK1 </a:t>
                      </a:r>
                      <a:r>
                        <a:rPr lang="en-GB" sz="900" u="none" strike="noStrike" dirty="0" err="1">
                          <a:effectLst/>
                        </a:rPr>
                        <a:t>inhibition+cGAMP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92961898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Scr+ULK1 </a:t>
                      </a:r>
                      <a:r>
                        <a:rPr lang="en-GB" sz="900" u="none" strike="noStrike" dirty="0" err="1">
                          <a:effectLst/>
                        </a:rPr>
                        <a:t>inhibition+cGAMP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133885003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Scr+ULK1 </a:t>
                      </a:r>
                      <a:r>
                        <a:rPr lang="en-GB" sz="900" u="none" strike="noStrike" dirty="0" err="1">
                          <a:effectLst/>
                        </a:rPr>
                        <a:t>inhibition+cGAMP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07842948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ATG5 K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11754137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ATG5 K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7010778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>
                          <a:effectLst/>
                        </a:rPr>
                        <a:t>ATG5 K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04283059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KO+ 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18136014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KO+ 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115811143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KO+ cGAMP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36385039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+H-1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76369629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+H-1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09238052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ATG5 KO+H-1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385130536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04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92680308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97308008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Sc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4149680906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Lane 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>
                          <a:effectLst/>
                        </a:rPr>
                        <a:t>Z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900" u="none" strike="noStrike" dirty="0" err="1">
                          <a:effectLst/>
                        </a:rPr>
                        <a:t>Sc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79" marR="7679" marT="7679" marB="0" anchor="b"/>
                </a:tc>
                <a:extLst>
                  <a:ext uri="{0D108BD9-81ED-4DB2-BD59-A6C34878D82A}">
                    <a16:rowId xmlns:a16="http://schemas.microsoft.com/office/drawing/2014/main" val="172145474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A782664-177C-1E30-C48D-32EEB3FA1A0E}"/>
              </a:ext>
            </a:extLst>
          </p:cNvPr>
          <p:cNvSpPr txBox="1"/>
          <p:nvPr/>
        </p:nvSpPr>
        <p:spPr>
          <a:xfrm>
            <a:off x="391874" y="3253799"/>
            <a:ext cx="50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E" dirty="0"/>
              <a:t>37-</a:t>
            </a:r>
          </a:p>
        </p:txBody>
      </p:sp>
    </p:spTree>
    <p:extLst>
      <p:ext uri="{BB962C8B-B14F-4D97-AF65-F5344CB8AC3E}">
        <p14:creationId xmlns:p14="http://schemas.microsoft.com/office/powerpoint/2010/main" val="2047613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78</Words>
  <Application>Microsoft Macintosh PowerPoint</Application>
  <PresentationFormat>Widescreen</PresentationFormat>
  <Paragraphs>28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 Jacobs</dc:creator>
  <cp:lastModifiedBy>Kathryn Jacobs</cp:lastModifiedBy>
  <cp:revision>1</cp:revision>
  <dcterms:created xsi:type="dcterms:W3CDTF">2023-09-29T16:26:25Z</dcterms:created>
  <dcterms:modified xsi:type="dcterms:W3CDTF">2023-10-01T13:54:37Z</dcterms:modified>
</cp:coreProperties>
</file>